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1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5840"/>
  </p:normalViewPr>
  <p:slideViewPr>
    <p:cSldViewPr snapToGrid="0">
      <p:cViewPr varScale="1">
        <p:scale>
          <a:sx n="112" d="100"/>
          <a:sy n="112" d="100"/>
        </p:scale>
        <p:origin x="576" y="19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8364FE3-3D37-C5F7-485D-3036482A5F2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BC4F4E84-E28B-C710-13E9-3371BD8DCC6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5DB89EC-C384-82D5-700D-B44243BE29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F197EAB-C668-64C1-47E4-4F6F149D2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E849EDD-579F-4438-8C80-6F3E8C92DF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144376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1DDB2-4F1A-F650-30AE-F8003E3E891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1ECF717-0C44-4FB0-0038-A031644004B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195AE9-D23F-B535-59C2-47A849D40FC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05DC40-4008-6A98-771F-6093A93648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F952FA1-EF83-CF99-20EE-59A2F1652B9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8303257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7472BE3-50AD-1414-377F-54CCBECFDF69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9C8B737C-B54C-7A74-299D-381A8216F7A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1B7559-8F29-5EDE-E57A-9C7AF143D0F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DD3832-771F-2F80-EE85-E362A9223D9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3856AA0-68BE-61F5-F5F8-6D9820C81A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604589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6B8EBE-E4F1-E20B-9111-71E5861BDD7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8949692-619E-1F6D-F622-C929758E1EB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E777BCE-0509-D3B4-6A9E-9588E94037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BDCC450-54E9-4EB4-E42A-93E6DE7A521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B7FCB3-329C-2A28-6833-A0FB36539AD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564690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3DDD8C3-C831-1398-3D91-A4F762C0289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B5811EA-2910-4CAC-D87F-2BC6D8D6FFA2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C115C7F-8326-7B90-362C-3189E47CDC0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9177FC-E185-BB5A-B0F1-704E60A98AE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38B4E65-E828-5693-1577-34B08FB12A1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122052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CB0DD2E-49B8-6396-7D80-6F35E554D98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144AD4E-C04A-EB21-0965-8DC162538C36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842EC30-5F9B-AC82-96DC-2CD00650715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F132D6-1AF5-81D8-D812-3FB7C38DF3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6D2199C-E204-5CC3-B9E8-0123E8E319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E1B584A-9E2B-79A1-760A-6F4F1BD25C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875581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08B034B-186C-D26D-55A9-47D4F4D72FD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945C70A-E5E9-C2BB-F5BB-878B7FDF942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9010DA-6419-77C3-5CC4-8D92DFBAD97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BB4F2A52-E923-2284-6D70-46003C49065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DF061ED-B10E-40D1-6A89-2DD43649C22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1F6E297-7135-7489-60BD-C9CA63335F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D17014B9-CC72-9224-E4C3-718EDCF264B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C7F284A8-8298-30D3-8D6A-F2A7FBA941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17833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5AAA4E-5542-7533-51BD-D1F29CD337D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9846BFC-0194-A48F-5186-1E76DD52BF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D6EB2D13-4521-2361-FB73-310AFE0992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5D20492-4868-B0BC-7D9E-4AF395A170C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873344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6D57F19-DB98-79B1-62DA-84CAE3F65D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7BC9A06-FB4E-277E-E786-470B5F72EE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93C5637B-085A-48E6-744A-31A93DC8FE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6400638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CDF04BC-129F-2505-2AA8-D30C2B75681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F8F7A3F-98A4-AE1A-CD42-5A3E06FC23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8BFB3C9-CFB2-080F-BEE4-A3E31BE041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867B6CA-F885-BFAF-1A67-98B388FCCA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72C88EC-1671-2898-F102-209CB91ACD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3DD9007-CB7D-D1F1-5F39-6C5C9DCC11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936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A62647-2EC5-88E0-BD7C-982E39AB760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9A8277F3-7583-1846-18EC-7318F7DDF7C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15B8D6A-C418-26F8-020A-FE5D7B9B767B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3747DE5-C0A4-882C-8E53-F75252230B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12495F9-A8A2-4E52-7E99-D81895140D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7CD4D1F-3F24-D004-91BF-C52DAD806DD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3173111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E54DA1A0-39FE-25B4-F694-044FC08C411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0130BBA-608D-5C32-A227-F9672034F25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C9190F-2CD2-635D-7028-501B85364A4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9FD3066-EEEE-3647-A6B8-B6B2C2A3673D}" type="datetimeFigureOut">
              <a:rPr lang="en-US" smtClean="0"/>
              <a:t>2/20/24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F754CED-14A8-5954-9BDE-CDCC14DEE0A3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59AB25C-235C-033B-C178-1FE37A2A78F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2D088F-1441-E447-A4EC-5A75D6EAD22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63908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A50C9A3F-6E96-C115-AA1B-3288C7A3C676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4053" r="2952"/>
          <a:stretch/>
        </p:blipFill>
        <p:spPr>
          <a:xfrm>
            <a:off x="152400" y="670582"/>
            <a:ext cx="8138160" cy="6349116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78833D5-AD9F-3DF4-DB9F-4D9D2BF315BB}"/>
              </a:ext>
            </a:extLst>
          </p:cNvPr>
          <p:cNvSpPr txBox="1"/>
          <p:nvPr/>
        </p:nvSpPr>
        <p:spPr>
          <a:xfrm>
            <a:off x="0" y="-152400"/>
            <a:ext cx="11824335" cy="127727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>
              <a:lnSpc>
                <a:spcPct val="150000"/>
              </a:lnSpc>
            </a:pPr>
            <a:r>
              <a:rPr lang="en-GB" sz="1400">
                <a:solidFill>
                  <a:srgbClr val="000000"/>
                </a:solidFill>
                <a:latin typeface="+mj-lt"/>
              </a:rPr>
              <a:t>Figure S4: </a:t>
            </a:r>
            <a:r>
              <a:rPr lang="en-GB" sz="1400" dirty="0">
                <a:solidFill>
                  <a:srgbClr val="000000"/>
                </a:solidFill>
                <a:latin typeface="+mj-lt"/>
              </a:rPr>
              <a:t>Bland-Altman plot showing the </a:t>
            </a:r>
            <a:r>
              <a:rPr lang="en-GB" sz="1400" b="0" i="0" dirty="0">
                <a:solidFill>
                  <a:srgbClr val="2E2E2E"/>
                </a:solidFill>
                <a:effectLst/>
                <a:latin typeface="+mj-lt"/>
              </a:rPr>
              <a:t>the mean and difference (Session 1 – Session 2) between the ALFF estimates </a:t>
            </a:r>
            <a:r>
              <a:rPr lang="en-GB" sz="1400" dirty="0">
                <a:solidFill>
                  <a:srgbClr val="2E2E2E"/>
                </a:solidFill>
                <a:latin typeface="+mj-lt"/>
              </a:rPr>
              <a:t>for a) </a:t>
            </a:r>
            <a:r>
              <a:rPr lang="en-GB" sz="1400" kern="0" dirty="0">
                <a:effectLst/>
                <a:latin typeface="+mj-lt"/>
                <a:ea typeface="Times New Roman" panose="02020603050405020304" pitchFamily="18" charset="0"/>
              </a:rPr>
              <a:t>Siemens </a:t>
            </a:r>
            <a:r>
              <a:rPr lang="en-GB" sz="1400" kern="0" dirty="0" err="1">
                <a:effectLst/>
                <a:latin typeface="+mj-lt"/>
                <a:ea typeface="Times New Roman" panose="02020603050405020304" pitchFamily="18" charset="0"/>
              </a:rPr>
              <a:t>Skyra</a:t>
            </a:r>
            <a:r>
              <a:rPr lang="en-GB" sz="1400" kern="0" dirty="0">
                <a:effectLst/>
                <a:latin typeface="+mj-lt"/>
                <a:ea typeface="Times New Roman" panose="02020603050405020304" pitchFamily="18" charset="0"/>
              </a:rPr>
              <a:t>, b) Philips Elition X, c) GE Signa and d) Siemens Vida respectively</a:t>
            </a:r>
            <a:r>
              <a:rPr lang="en-GB" sz="1400" dirty="0">
                <a:effectLst/>
                <a:latin typeface="+mj-lt"/>
              </a:rPr>
              <a:t> </a:t>
            </a:r>
            <a:r>
              <a:rPr lang="en-GB" sz="1400" b="0" i="0" dirty="0">
                <a:solidFill>
                  <a:srgbClr val="2E2E2E"/>
                </a:solidFill>
                <a:effectLst/>
                <a:latin typeface="+mj-lt"/>
              </a:rPr>
              <a:t>. In this plot each point corresponds to  AAL113 </a:t>
            </a:r>
            <a:r>
              <a:rPr lang="en-GB" sz="1400" b="0" i="0" dirty="0" err="1">
                <a:solidFill>
                  <a:srgbClr val="2E2E2E"/>
                </a:solidFill>
                <a:effectLst/>
                <a:latin typeface="+mj-lt"/>
              </a:rPr>
              <a:t>ROsI</a:t>
            </a:r>
            <a:r>
              <a:rPr lang="en-GB" sz="1400" dirty="0">
                <a:solidFill>
                  <a:srgbClr val="2E2E2E"/>
                </a:solidFill>
                <a:latin typeface="+mj-lt"/>
              </a:rPr>
              <a:t>, black </a:t>
            </a:r>
            <a:r>
              <a:rPr lang="en-GB" sz="1400" b="0" i="0" dirty="0">
                <a:solidFill>
                  <a:srgbClr val="000000"/>
                </a:solidFill>
                <a:effectLst/>
                <a:latin typeface="+mj-lt"/>
              </a:rPr>
              <a:t>Horizontal depicts the mean difference, and red horizontal lines depicts the limits of agreement (</a:t>
            </a:r>
            <a:r>
              <a:rPr lang="en-GB" sz="1400" b="0" i="0" dirty="0" err="1">
                <a:solidFill>
                  <a:srgbClr val="000000"/>
                </a:solidFill>
                <a:effectLst/>
                <a:latin typeface="+mj-lt"/>
              </a:rPr>
              <a:t>LoA</a:t>
            </a:r>
            <a:r>
              <a:rPr lang="en-GB" sz="1400" b="0" i="0" dirty="0">
                <a:solidFill>
                  <a:srgbClr val="000000"/>
                </a:solidFill>
                <a:effectLst/>
                <a:latin typeface="+mj-lt"/>
              </a:rPr>
              <a:t>) and are defined as the mean difference ± 1.96 SD of differences</a:t>
            </a:r>
            <a:r>
              <a:rPr lang="en-GB" sz="1400" b="0" i="0" dirty="0"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.</a:t>
            </a:r>
          </a:p>
          <a:p>
            <a:endParaRPr lang="en-US" sz="1400" dirty="0"/>
          </a:p>
        </p:txBody>
      </p:sp>
    </p:spTree>
    <p:extLst>
      <p:ext uri="{BB962C8B-B14F-4D97-AF65-F5344CB8AC3E}">
        <p14:creationId xmlns:p14="http://schemas.microsoft.com/office/powerpoint/2010/main" val="247123695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87</Words>
  <Application>Microsoft Macintosh PowerPoint</Application>
  <PresentationFormat>Widescreen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Wajiha Bano</dc:creator>
  <cp:lastModifiedBy>Wajiha Bano</cp:lastModifiedBy>
  <cp:revision>3</cp:revision>
  <dcterms:created xsi:type="dcterms:W3CDTF">2023-08-15T12:51:34Z</dcterms:created>
  <dcterms:modified xsi:type="dcterms:W3CDTF">2024-02-20T20:15:07Z</dcterms:modified>
</cp:coreProperties>
</file>